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A5A5A5"/>
    <a:srgbClr val="0000FF"/>
    <a:srgbClr val="FF0000"/>
    <a:srgbClr val="00FFCC"/>
    <a:srgbClr val="CC339B"/>
    <a:srgbClr val="FFFF00"/>
    <a:srgbClr val="CC3399"/>
    <a:srgbClr val="0033CC"/>
    <a:srgbClr val="DE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48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931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6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88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009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347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393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939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615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5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642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572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B3B33-E876-45D0-8B82-516B10A43362}" type="datetimeFigureOut">
              <a:rPr lang="en-US" smtClean="0"/>
              <a:t>7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0322D-C954-4326-9E80-3FBE11BB2F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18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7" name="Straight Arrow Connector 26"/>
          <p:cNvCxnSpPr/>
          <p:nvPr/>
        </p:nvCxnSpPr>
        <p:spPr>
          <a:xfrm flipV="1">
            <a:off x="5050973" y="3592282"/>
            <a:ext cx="1" cy="5805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863348" y="4189365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i</a:t>
            </a:r>
          </a:p>
        </p:txBody>
      </p:sp>
      <p:grpSp>
        <p:nvGrpSpPr>
          <p:cNvPr id="30" name="Group 29"/>
          <p:cNvGrpSpPr>
            <a:grpSpLocks noChangeAspect="1"/>
          </p:cNvGrpSpPr>
          <p:nvPr/>
        </p:nvGrpSpPr>
        <p:grpSpPr>
          <a:xfrm>
            <a:off x="418337" y="865570"/>
            <a:ext cx="9228202" cy="4320000"/>
            <a:chOff x="145141" y="1552105"/>
            <a:chExt cx="9802934" cy="458904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141" y="1552105"/>
              <a:ext cx="9085945" cy="3679475"/>
            </a:xfrm>
            <a:prstGeom prst="rect">
              <a:avLst/>
            </a:prstGeom>
          </p:spPr>
        </p:pic>
        <p:cxnSp>
          <p:nvCxnSpPr>
            <p:cNvPr id="6" name="Straight Arrow Connector 5"/>
            <p:cNvCxnSpPr/>
            <p:nvPr/>
          </p:nvCxnSpPr>
          <p:spPr>
            <a:xfrm flipV="1">
              <a:off x="624114" y="4136572"/>
              <a:ext cx="1" cy="5805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1161141" y="2859314"/>
              <a:ext cx="46445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flipV="1">
              <a:off x="3142344" y="5140450"/>
              <a:ext cx="1" cy="5805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>
              <a:off x="1777998" y="2097314"/>
              <a:ext cx="46445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 flipV="1">
              <a:off x="3933372" y="5154964"/>
              <a:ext cx="1" cy="5805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 flipV="1">
              <a:off x="6219371" y="3947886"/>
              <a:ext cx="1" cy="5805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 flipV="1">
              <a:off x="7024915" y="3449897"/>
              <a:ext cx="1" cy="5805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H="1">
              <a:off x="7489372" y="1988456"/>
              <a:ext cx="1" cy="53702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 flipV="1">
              <a:off x="8251371" y="2789498"/>
              <a:ext cx="1" cy="58057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 flipH="1">
              <a:off x="9260114" y="2731442"/>
              <a:ext cx="2743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13855" y="4746134"/>
              <a:ext cx="4363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P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775758" y="2674648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F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302692" y="1899361"/>
              <a:ext cx="5629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CC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948275" y="5721021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C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739300" y="5771821"/>
              <a:ext cx="4603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C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060774" y="4559483"/>
              <a:ext cx="4122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T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828527" y="4030431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A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054985" y="3384545"/>
              <a:ext cx="4010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T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301747" y="1619124"/>
              <a:ext cx="4119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T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9462045" y="2532262"/>
              <a:ext cx="486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RP</a:t>
              </a:r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6203925" y="65232"/>
            <a:ext cx="532720" cy="532720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6629544" y="229307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S</a:t>
            </a:r>
          </a:p>
        </p:txBody>
      </p:sp>
      <p:sp>
        <p:nvSpPr>
          <p:cNvPr id="40" name="Rectangle 39"/>
          <p:cNvSpPr/>
          <p:nvPr/>
        </p:nvSpPr>
        <p:spPr>
          <a:xfrm>
            <a:off x="193185" y="5382583"/>
            <a:ext cx="9564913" cy="14754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6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sz="16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iagrammatic representation of the two-choice Y-olfactometer. The olfactometer consisted of a 20-cm-long stem tube with 1.5 cm inner diameter and two 12-cm-long lateral arms with a </a:t>
            </a:r>
            <a:r>
              <a:rPr lang="en-US" sz="160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60°angle </a:t>
            </a:r>
            <a:r>
              <a:rPr lang="en-US" sz="16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the Y-junction. The detailed depiction of the various parts and connections is as follows: ACC, activated charcoal chamber; AF, air flowmeter (400 ml/min); AI, air inlet; AP, air pump; AT, arm tube; CA, choice area; HC, humidifier chamber; IRP, insect release point; LS, lighting source; OC, odor chamber; ST, stem tube; TT, Teflon tubes. 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endParaRPr lang="en-US" sz="1600" dirty="0">
              <a:effectLst/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9773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6</TotalTime>
  <Words>128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lam Sobhy</dc:creator>
  <cp:lastModifiedBy>Islam Sobhy</cp:lastModifiedBy>
  <cp:revision>72</cp:revision>
  <cp:lastPrinted>2017-06-23T09:41:49Z</cp:lastPrinted>
  <dcterms:created xsi:type="dcterms:W3CDTF">2016-10-20T21:44:26Z</dcterms:created>
  <dcterms:modified xsi:type="dcterms:W3CDTF">2018-07-02T13:59:48Z</dcterms:modified>
</cp:coreProperties>
</file>